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0" d="100"/>
          <a:sy n="70" d="100"/>
        </p:scale>
        <p:origin x="1662" y="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6A6DC-93CD-4430-9969-79016502A61F}" type="datetimeFigureOut">
              <a:rPr lang="ko-KR" altLang="en-US" smtClean="0"/>
              <a:t>2018-06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FA3B0-854D-4A13-AFB2-79F451D61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42916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6A6DC-93CD-4430-9969-79016502A61F}" type="datetimeFigureOut">
              <a:rPr lang="ko-KR" altLang="en-US" smtClean="0"/>
              <a:t>2018-06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FA3B0-854D-4A13-AFB2-79F451D61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798360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6A6DC-93CD-4430-9969-79016502A61F}" type="datetimeFigureOut">
              <a:rPr lang="ko-KR" altLang="en-US" smtClean="0"/>
              <a:t>2018-06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FA3B0-854D-4A13-AFB2-79F451D61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2953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6A6DC-93CD-4430-9969-79016502A61F}" type="datetimeFigureOut">
              <a:rPr lang="ko-KR" altLang="en-US" smtClean="0"/>
              <a:t>2018-06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FA3B0-854D-4A13-AFB2-79F451D61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50606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6A6DC-93CD-4430-9969-79016502A61F}" type="datetimeFigureOut">
              <a:rPr lang="ko-KR" altLang="en-US" smtClean="0"/>
              <a:t>2018-06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FA3B0-854D-4A13-AFB2-79F451D61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0549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6A6DC-93CD-4430-9969-79016502A61F}" type="datetimeFigureOut">
              <a:rPr lang="ko-KR" altLang="en-US" smtClean="0"/>
              <a:t>2018-06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FA3B0-854D-4A13-AFB2-79F451D61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2154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6A6DC-93CD-4430-9969-79016502A61F}" type="datetimeFigureOut">
              <a:rPr lang="ko-KR" altLang="en-US" smtClean="0"/>
              <a:t>2018-06-0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FA3B0-854D-4A13-AFB2-79F451D61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3945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6A6DC-93CD-4430-9969-79016502A61F}" type="datetimeFigureOut">
              <a:rPr lang="ko-KR" altLang="en-US" smtClean="0"/>
              <a:t>2018-06-0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FA3B0-854D-4A13-AFB2-79F451D61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70521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6A6DC-93CD-4430-9969-79016502A61F}" type="datetimeFigureOut">
              <a:rPr lang="ko-KR" altLang="en-US" smtClean="0"/>
              <a:t>2018-06-0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FA3B0-854D-4A13-AFB2-79F451D61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21036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6A6DC-93CD-4430-9969-79016502A61F}" type="datetimeFigureOut">
              <a:rPr lang="ko-KR" altLang="en-US" smtClean="0"/>
              <a:t>2018-06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FA3B0-854D-4A13-AFB2-79F451D61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05706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86A6DC-93CD-4430-9969-79016502A61F}" type="datetimeFigureOut">
              <a:rPr lang="ko-KR" altLang="en-US" smtClean="0"/>
              <a:t>2018-06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FA3B0-854D-4A13-AFB2-79F451D61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402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86A6DC-93CD-4430-9969-79016502A61F}" type="datetimeFigureOut">
              <a:rPr lang="ko-KR" altLang="en-US" smtClean="0"/>
              <a:t>2018-06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FFA3B0-854D-4A13-AFB2-79F451D61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28672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0715" y="1419063"/>
            <a:ext cx="5057775" cy="3914775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296215" y="5380004"/>
            <a:ext cx="6139637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 Fig. Quantile–Quantile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plot of the genome wide </a:t>
            </a:r>
            <a:r>
              <a:rPr lang="en-US" altLang="ko-KR" sz="1200" b="1">
                <a:latin typeface="Arial" panose="020B0604020202020204" pitchFamily="34" charset="0"/>
                <a:cs typeface="Arial" panose="020B0604020202020204" pitchFamily="34" charset="0"/>
              </a:rPr>
              <a:t>association </a:t>
            </a:r>
            <a:r>
              <a:rPr lang="en-US" altLang="ko-KR" sz="1200" b="1" smtClean="0">
                <a:latin typeface="Arial" panose="020B0604020202020204" pitchFamily="34" charset="0"/>
                <a:cs typeface="Arial" panose="020B0604020202020204" pitchFamily="34" charset="0"/>
              </a:rPr>
              <a:t>study (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GWAS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distributions of observed p-values did not deviate from the null distribution, which excluded systematic bias due to bad genotyping or population structure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y-axis is the observed -log10(p) values; the x-axis is the expected -log10(p) values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genomic control inflation factor (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λ) is 0.893.</a:t>
            </a:r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66461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</TotalTime>
  <Words>70</Words>
  <Application>Microsoft Office PowerPoint</Application>
  <PresentationFormat>A4 용지(210x297mm)</PresentationFormat>
  <Paragraphs>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ooLab_LEJ</dc:creator>
  <cp:lastModifiedBy>user</cp:lastModifiedBy>
  <cp:revision>10</cp:revision>
  <dcterms:created xsi:type="dcterms:W3CDTF">2017-03-21T05:30:21Z</dcterms:created>
  <dcterms:modified xsi:type="dcterms:W3CDTF">2018-06-07T11:22:53Z</dcterms:modified>
</cp:coreProperties>
</file>